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CCF1B-8B1A-4C97-BE95-6F84F627E547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E418-E8A0-456B-BBAC-0421B94CF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278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CCF1B-8B1A-4C97-BE95-6F84F627E547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E418-E8A0-456B-BBAC-0421B94CF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4267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CCF1B-8B1A-4C97-BE95-6F84F627E547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E418-E8A0-456B-BBAC-0421B94CF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302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CCF1B-8B1A-4C97-BE95-6F84F627E547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E418-E8A0-456B-BBAC-0421B94CF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4424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CCF1B-8B1A-4C97-BE95-6F84F627E547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E418-E8A0-456B-BBAC-0421B94CF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445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CCF1B-8B1A-4C97-BE95-6F84F627E547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E418-E8A0-456B-BBAC-0421B94CF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820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CCF1B-8B1A-4C97-BE95-6F84F627E547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E418-E8A0-456B-BBAC-0421B94CF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170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CCF1B-8B1A-4C97-BE95-6F84F627E547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E418-E8A0-456B-BBAC-0421B94CF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114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CCF1B-8B1A-4C97-BE95-6F84F627E547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E418-E8A0-456B-BBAC-0421B94CF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348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CCF1B-8B1A-4C97-BE95-6F84F627E547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E418-E8A0-456B-BBAC-0421B94CF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0413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CCF1B-8B1A-4C97-BE95-6F84F627E547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E418-E8A0-456B-BBAC-0421B94CF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098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CCF1B-8B1A-4C97-BE95-6F84F627E547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8E418-E8A0-456B-BBAC-0421B94CFD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785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28831" y="68267"/>
            <a:ext cx="11854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Figure S4</a:t>
            </a:r>
            <a:endParaRPr lang="en-US" dirty="0">
              <a:latin typeface="Arial"/>
              <a:cs typeface="Arial"/>
            </a:endParaRPr>
          </a:p>
        </p:txBody>
      </p:sp>
      <p:pic>
        <p:nvPicPr>
          <p:cNvPr id="4" name="Picture 3" descr="FigS4_pwcorr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400" y="437599"/>
            <a:ext cx="7518400" cy="5467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12572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715070" y="163774"/>
            <a:ext cx="8830101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ure S4. Pairwise scatterplots of baseline, final and delta PC</a:t>
            </a:r>
            <a:r>
              <a:rPr lang="en-US" baseline="-25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150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Baseline and final PC</a:t>
            </a:r>
            <a:r>
              <a:rPr lang="en-US" baseline="-25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150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were ln-transformed. See Table 2 for Pearson correlation values. Two primary observations were made from this plot, first that baseline and final PC</a:t>
            </a:r>
            <a:r>
              <a:rPr lang="en-US" baseline="-25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150 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were strongly correlated; second, low baseline responsiveness to methacholine (i.e., large PC</a:t>
            </a:r>
            <a:r>
              <a:rPr lang="en-US" baseline="-25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150 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values) were associated with the largest delta PC</a:t>
            </a:r>
            <a:r>
              <a:rPr lang="en-US" baseline="-250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150 </a:t>
            </a:r>
            <a:r>
              <a:rPr lang="en-US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values.</a:t>
            </a:r>
          </a:p>
        </p:txBody>
      </p:sp>
    </p:spTree>
    <p:extLst>
      <p:ext uri="{BB962C8B-B14F-4D97-AF65-F5344CB8AC3E}">
        <p14:creationId xmlns:p14="http://schemas.microsoft.com/office/powerpoint/2010/main" val="35891226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MS Mincho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Wolper</dc:creator>
  <cp:lastModifiedBy>Sarah Wolper</cp:lastModifiedBy>
  <cp:revision>1</cp:revision>
  <dcterms:created xsi:type="dcterms:W3CDTF">2016-07-20T19:35:55Z</dcterms:created>
  <dcterms:modified xsi:type="dcterms:W3CDTF">2016-07-20T19:36:04Z</dcterms:modified>
</cp:coreProperties>
</file>